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FEE10-3336-4DD6-9E91-1D06C81CCE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B3CC5-59F7-46BE-9622-82A21DA93C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5B2DCC9-99C9-4015-8297-9BE958B477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DED619F-DCE4-436B-A404-94E89369CD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127F760-FBF7-42BA-A4B3-F4A8D8959C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98138D9-6E24-4D35-9D7F-0A8B3D3A28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352634B-CD79-4CAF-9EF6-FE0DCCA5AC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E71F74A-A9E2-4CBD-86C8-14CE665502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CA36F87-4FE4-4F61-9B40-C3250AA9D4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BD528EA-2F33-4435-9D12-C782059DDD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D84F12A-1BF5-4D73-80AB-79256BD60E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7209504-6107-43E1-8B11-5067FDB926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86056-91A0-4020-8A55-2DBEEF411A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AD8D7CF-56AD-4A80-9699-AFBDD1B30D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291E097-D3C3-4CDA-AC78-7746EE34F0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6F50FE7-B7DE-44C5-9603-9490F964FE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4416C1E-65EF-4F34-9A08-B533C3B242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CEA510F-B5CA-45D7-8F13-C9A8DEB06D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BAB6BB5-7C73-45B4-B105-DE83B53C94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1FDF965-8AC7-4BE4-8510-21D1185D82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14FC78F-4F93-4CBF-8BE1-AB0E67CA1A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E18BFE9-7149-47B8-AB89-B1124C9045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C389355-1121-40B7-A99D-5CEC16A170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2123A-B27E-43F2-8EF6-1ADAF13E2F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95BE105-AAAF-4C10-A4D0-493A9CFE5F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00593E6-BF5B-44A0-9173-B2335177EB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9B48C4F-9236-474C-9B21-22FD3FE445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5125B09-EBA5-431B-9068-FB75290E02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CD2B596-7F88-46CE-A17A-89A2E4ED12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59EE8AD-DEF1-4876-8053-767453CA33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9D1EAC7-780A-4EF3-B186-FC3FAB8D8A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B73AA7A-7EA4-4B46-98E0-FF6BBBB38D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C17E8CA-2DE7-4E93-BBCC-AA0E5977DA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4E3EC50-415B-4CE7-AC7A-F54B69195E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51D1B4-0B8A-42E0-9573-E2BCA318B8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9E024C5-9C49-46AF-A277-70D6B47218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DA3ADAC-86C4-4BA8-AD0B-F3505E194A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5F07DF8-8175-4890-930C-6D4784D25A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CBB4127-08EA-4220-917E-9FDB8C25C0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40B2DBC-C70B-4B23-BC3E-16FD88E6BB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64E91D88-3991-488C-88CC-1E03C8554B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6B1A83A-4EC0-4BD1-9677-AA5CE2A7B9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1B8BB97-31B7-452E-8B41-E64FDA427B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7CED2CA-A17E-438D-8021-70A3EE61A1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FB09AEF-0DD9-4DC4-8B2C-395C6426D9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2B83C38-5011-44D9-9AB6-1392B59E75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FF63350-D702-41C9-85BA-731EEB2F21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B2E2253-1701-454B-A425-DCEEA322EC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0CBFEDD-2351-4EF5-9C32-9CF3BB25FF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DA678DF-9C4B-4FD5-986F-BA65D9E452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536C0149-DB52-4333-87C2-163AA7F144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87E94CE-A32C-42B1-813C-33248A90EF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E96EE9-6F1E-4077-8972-2128996CB6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35EEC6A-31CB-4096-B5E5-8A88B6B15C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FA8DD6D-BCB8-419D-BE2A-146D8B14B5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9098ED1-C2C6-4CB5-97AC-3931A3AAAC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A8D58-54E0-40D7-A475-9AC0A35806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0BD792E-B56D-4F45-A9B2-BD69B72CE2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F5433EB-6107-47BC-95D6-E9A5330934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41E3BD4-90A4-44C3-A0DD-C421ADA169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8CAEA79-AEFD-49D0-ABDF-3EE9D1CB0E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9BE15BC-1240-490A-B3BA-974163954B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8AC9340-52BD-492A-8128-6F75B11C52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452B546-3070-46B6-9241-D31E99F71D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8575795-65F0-457F-A691-4318097058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6A5DEF5-3826-4793-BEC6-16778CDD3A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F9F1DDE-F9A2-4AC7-BBB0-B24EE1811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32587-EC44-4537-B879-AE6416125C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5D32112-0426-41EB-8B0C-9A1100AE3B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8BF536F-D86E-4688-A1BF-AF421DCBF7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DC687D5-71D2-4FA7-84E5-BCD2C919E8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D314970-567C-41A5-A6F0-F53F9B2200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DD63803-CDAE-4648-8D2B-8BA9650330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0475ACB-0F88-41D7-AE2F-09438120A3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8106BC2-6B2E-42F8-8410-4291C7FF7C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36CDCF0-CC9C-4070-9950-CB12F60971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6A57DE4-CAB8-453B-9BF1-5CA0872EA8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D5253CF-FEEB-4501-A342-9ECB49F45E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0896E-3E7D-44C7-A5ED-A661C827A6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7B27914-5B8B-474F-B7DF-0E47928ACB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265D9A3-8B58-42D0-83E7-EA739C60BB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DF3D733-8A82-4479-8A0E-D092BBD303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94AC802-0E8C-4F35-B97B-F3B2C9F62A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84AB228-CC41-46EC-8710-9F4E551C53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DF57D88-6CA7-4628-8B1C-9E6818A69F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2E38CDD-6EDB-4D7E-AFDD-5C601C7CC4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B9AF231-5ED1-48B1-8686-B0DDE7CDAF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58DDA4F-4428-4833-82B1-3C97DE5151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9ECCDC7-F971-407D-94C8-28FCF7010B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3B081-9BF6-480F-A62F-79F2E86B98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42CB176-C8AC-48B7-B7EE-B9A0E0E8B5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9E73E6C-DA11-4E3A-8253-48A5A7C6A3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9FF3C84-203F-4A31-840E-0C76D6771E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44BA159-2191-4D82-A14A-8E4A328284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18B18DD-5C3E-45C4-A4E0-BA2D9B7EDC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B54D0E9-2B8D-4E83-BB8A-3E552E72D1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7FA9DD5-9768-42A8-90CA-4B260BF855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285D0D5-400A-4A08-B19F-A3446189C1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14E7711-22F3-433E-B5BC-F1873828C1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93880B5-5D67-430F-BD28-F93EB8B90A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3AADB-7395-4918-B34B-5B6C341D71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4F8A16B-7B24-4824-8591-5CF25B81D0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D040914-EE5E-46BD-BC84-2885AE59C1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B870CAD-BC06-49EE-8E59-D22DD7E949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D8A8423-8AC0-4231-9658-A76B14A5CB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6C9E263-5408-40A8-8B3E-6B7BDF1D40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0466F23-DD6F-4342-8E3C-1C57758765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3A906D5-F0F2-47F0-A8F9-2489A15EF4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7ED0645-144A-490A-AEE6-63CEEFCE16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48587AA-E489-43F5-BDDC-9574DBBD22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21E5F98-EE46-4B5B-94B5-16A37B8DD3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0C6FD-9257-4D64-8CF3-D0428BB631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FCEE8D4-4181-456A-80B1-4732638DC9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BD796E6-C14A-411E-BBC7-936AE70DE8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E7C2A81-1599-4A23-8E84-5A9CE91702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6B104D7-2B2D-45D0-A369-5CE71BF7A3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AAD7BCD-A296-497F-AE40-37994E371A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EFFE39D-9628-479F-9F63-5B0C1CE09F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973AB05-4757-46A9-B2B0-CA7B1CEBF3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828EE2E-54CB-4551-A9C7-D8574A213A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22A0655-D886-4EBC-A9D8-7BE2FEB878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1AD1143-568B-4F0B-8796-3E3C2B7852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DD029-D793-4628-B092-7F8CC2C7A2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ABF8AD7-8649-4FBD-95E7-D5F31687C2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319DB23-50A2-4C6C-8A34-6BA573B936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8A69211-E6A9-4A1F-A32D-71902FAE7B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A80FE4D-C274-4567-A109-9EE5F4718F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DDAF477-9376-4053-ADEE-27B2997DBF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A9188AE-7C5A-4939-B67C-60F63C7F66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C1E8B36-5E0A-4856-820C-D89718F860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45993D7-2CA0-4B36-A539-B04620637F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958F8A0-5C90-4FDA-95B5-0A9CC479FB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1CB4231-7D1E-4791-BEA4-97D2AE6183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1C4AF-552A-4CBA-821F-6FE994AA7B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F073CE7-9899-46B4-8C46-6EACABE319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6806221-C6B1-44E4-B827-AA2F15FF2A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B0F1C93-5B2A-4E86-BA82-A5518178E6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90222F3-EC8C-4010-87A8-C2C4AD39D1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CC0D7A2-97C7-4CCE-8E15-10532C6D79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8994E69-2624-4D11-9070-7333FC1149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2D6DCA4-9C7B-4B7F-95FE-175B046FCC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F8CB308-8C2C-412F-B7B3-2E72DEDE2E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3E8F849-F3B6-4442-935B-83A4871776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9F38BF4-41A1-482A-A1EA-07E1553E35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5388A8-8147-43ED-89CA-0AD31FE4C68E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4DE6EA-F164-44A5-8C3D-1BCDD6FDF31E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64BBBD-766A-450F-80AF-AE57CA3BA375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DEF7C7-B85C-458D-975B-633086595BF0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7F3C0F-A12D-44C9-9ED7-B2987920A449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C7D8A7-2447-4F5C-8E70-1E2DCEA39192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947CAA-7857-4D5D-9712-B81B4F6F2C65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3128F9-2654-4012-A512-D63BDFC820C3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027F8D-ACD6-46FC-9D95-B63FCF7F4A35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877A21-B521-447C-886A-EB90389433D7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EA4C83-B343-413D-AAB5-4C0516B82633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A98C97-BB17-475E-90DE-902255EB23AB}" type="slidenum">
              <a:rPr b="0" lang="ja-JP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8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テキスト ボックス 18"/>
          <p:cNvSpPr/>
          <p:nvPr/>
        </p:nvSpPr>
        <p:spPr>
          <a:xfrm>
            <a:off x="295200" y="250920"/>
            <a:ext cx="6265800" cy="344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terials and methods for supplemental inform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Regulatory T cell induction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plenic CD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 cells were collected using CD4 (L3T4) MicroBeads (MiltenyiBiotec, Belgish-Bladbach).</a:t>
            </a:r>
            <a:r>
              <a:rPr b="0" lang="ja-JP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o generate regulatory T cells (as a positive control), CD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 cells were cultured for 72 hours in RPMI-1640 high glucose supplemented with 0.1 mM non-essential amino acids, 1 mM sodium pyruvate, 100 μM beta-mercaptoethanol, 10% FBS, 100 U/ml penicillin and 100 μg/ml of streptomycin (all from Life Technologies, Carlsbad, CA) including 5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/ml of recombinant human TGF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 (Peprotech) and 2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/ml of mouse recombinant IL-2 (Peprotech) on anti-CD3 mAb-coated plate (96-well plate was pre-incubated with 1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/ml of anti-CD3 antibody (2C11) for 16 h before co-culture). To test the regulatory T cell induction capacity of  ES-SCs, CD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T cells were co-cultured for 72 hours with ES-SCs (ES-SCs; 2 x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cells, CD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T cells; 5 x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cells) in culture media described above without cytokines and anti-CD3 mAb-coated plate 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nsplantation and immunohistochemist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ost 129X1 or C3H mice were intraperitoneally injected with phosphate buffered saline (PBS) or 35 Gy-irradiated ES-SCs (1 x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14 days before transplantation. For the transplantation, differentiated cardiomyocytes (beating EBs) from E14 ESCs were collected, re-suspended in PBS, and transplanted in the host renal subcapsular region. 6 days later, kidneys were harvested and  embedded in Tissue-Tek OCT (Sakura Finetek, Torrance, CA). 5 μm-thick sections were stained with anti-CD3 antibody (2C11, Biolegend) or anti-F4/80 antibody (BM8, Biolegend) followed by Alexa 555 conjugated anti-rat IgG as secondary antibody. For co-staining, sections were stained with anti-F4/80 antibody and biotinilated-anti-H-2D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L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28-14-8, BD Pharmingen) followed by Alexa 488 conjugated anti-rat IgG and Alexa 555 streptavidin (Life technologies) conjugated streptavidin (Life technologies) as secondary antibody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cale bars, 100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18T15:52:43Z</dcterms:created>
  <dc:creator>きのこさん</dc:creator>
  <dc:description/>
  <dc:language>en-US</dc:language>
  <cp:lastModifiedBy>Flow jo</cp:lastModifiedBy>
  <cp:lastPrinted>2014-09-24T08:18:49Z</cp:lastPrinted>
  <dcterms:modified xsi:type="dcterms:W3CDTF">2014-10-10T04:31:40Z</dcterms:modified>
  <cp:revision>103</cp:revision>
  <dc:subject/>
  <dc:title>スライド 1</dc:title>
</cp:coreProperties>
</file>